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8"/>
  </p:notesMasterIdLst>
  <p:sldIdLst>
    <p:sldId id="263" r:id="rId2"/>
    <p:sldId id="268" r:id="rId3"/>
    <p:sldId id="265" r:id="rId4"/>
    <p:sldId id="266" r:id="rId5"/>
    <p:sldId id="264" r:id="rId6"/>
    <p:sldId id="267" r:id="rId7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>
        <p:scale>
          <a:sx n="94" d="100"/>
          <a:sy n="94" d="100"/>
        </p:scale>
        <p:origin x="-1368" y="-8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viewProps" Target="viewProps.xml"/><Relationship Id="rId12" Type="http://schemas.openxmlformats.org/officeDocument/2006/relationships/theme" Target="theme/theme1.xml"/><Relationship Id="rId13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notesMaster" Target="notesMasters/notesMaster1.xml"/><Relationship Id="rId9" Type="http://schemas.openxmlformats.org/officeDocument/2006/relationships/printerSettings" Target="printerSettings/printerSettings1.bin"/><Relationship Id="rId10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578B831-D6DD-A040-BFED-09BD49ADF854}" type="datetimeFigureOut">
              <a:rPr lang="en-US" smtClean="0"/>
              <a:t>25/08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098F65A-81E6-0444-98A7-798462E642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849257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098F65A-81E6-0444-98A7-798462E642EE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812305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70F68F-270C-CE42-B5AA-F91A7599DC1D}" type="datetimeFigureOut">
              <a:rPr lang="en-US" smtClean="0"/>
              <a:t>25/08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91F4BD-E30B-3445-92FB-7BB722F5E0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87300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70F68F-270C-CE42-B5AA-F91A7599DC1D}" type="datetimeFigureOut">
              <a:rPr lang="en-US" smtClean="0"/>
              <a:t>25/08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91F4BD-E30B-3445-92FB-7BB722F5E0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70797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70F68F-270C-CE42-B5AA-F91A7599DC1D}" type="datetimeFigureOut">
              <a:rPr lang="en-US" smtClean="0"/>
              <a:t>25/08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91F4BD-E30B-3445-92FB-7BB722F5E0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99568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70F68F-270C-CE42-B5AA-F91A7599DC1D}" type="datetimeFigureOut">
              <a:rPr lang="en-US" smtClean="0"/>
              <a:t>25/08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91F4BD-E30B-3445-92FB-7BB722F5E0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46346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70F68F-270C-CE42-B5AA-F91A7599DC1D}" type="datetimeFigureOut">
              <a:rPr lang="en-US" smtClean="0"/>
              <a:t>25/08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91F4BD-E30B-3445-92FB-7BB722F5E0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80241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70F68F-270C-CE42-B5AA-F91A7599DC1D}" type="datetimeFigureOut">
              <a:rPr lang="en-US" smtClean="0"/>
              <a:t>25/08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91F4BD-E30B-3445-92FB-7BB722F5E0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34032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70F68F-270C-CE42-B5AA-F91A7599DC1D}" type="datetimeFigureOut">
              <a:rPr lang="en-US" smtClean="0"/>
              <a:t>25/08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91F4BD-E30B-3445-92FB-7BB722F5E0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78481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70F68F-270C-CE42-B5AA-F91A7599DC1D}" type="datetimeFigureOut">
              <a:rPr lang="en-US" smtClean="0"/>
              <a:t>25/08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91F4BD-E30B-3445-92FB-7BB722F5E0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78860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70F68F-270C-CE42-B5AA-F91A7599DC1D}" type="datetimeFigureOut">
              <a:rPr lang="en-US" smtClean="0"/>
              <a:t>25/08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91F4BD-E30B-3445-92FB-7BB722F5E0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83068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70F68F-270C-CE42-B5AA-F91A7599DC1D}" type="datetimeFigureOut">
              <a:rPr lang="en-US" smtClean="0"/>
              <a:t>25/08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91F4BD-E30B-3445-92FB-7BB722F5E0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85910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70F68F-270C-CE42-B5AA-F91A7599DC1D}" type="datetimeFigureOut">
              <a:rPr lang="en-US" smtClean="0"/>
              <a:t>25/08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91F4BD-E30B-3445-92FB-7BB722F5E0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01789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70F68F-270C-CE42-B5AA-F91A7599DC1D}" type="datetimeFigureOut">
              <a:rPr lang="en-US" smtClean="0"/>
              <a:t>25/08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91F4BD-E30B-3445-92FB-7BB722F5E0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11016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4.emf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5.emf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6.emf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7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71249" y="99882"/>
            <a:ext cx="35714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upplementary Fig 1</a:t>
            </a:r>
            <a:endParaRPr lang="en-US" dirty="0"/>
          </a:p>
        </p:txBody>
      </p:sp>
      <p:pic>
        <p:nvPicPr>
          <p:cNvPr id="2" name="Picture 1" descr="Figure S1.eps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16047" y="1398218"/>
            <a:ext cx="6674749" cy="403907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7493334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71249" y="99882"/>
            <a:ext cx="35714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upplementary Fig </a:t>
            </a:r>
            <a:r>
              <a:rPr lang="en-US" dirty="0" smtClean="0"/>
              <a:t>2</a:t>
            </a:r>
            <a:endParaRPr lang="en-US" dirty="0"/>
          </a:p>
        </p:txBody>
      </p:sp>
      <p:grpSp>
        <p:nvGrpSpPr>
          <p:cNvPr id="9" name="Group 8"/>
          <p:cNvGrpSpPr/>
          <p:nvPr/>
        </p:nvGrpSpPr>
        <p:grpSpPr>
          <a:xfrm>
            <a:off x="324279" y="1208002"/>
            <a:ext cx="8198210" cy="3481602"/>
            <a:chOff x="324279" y="1208002"/>
            <a:chExt cx="8198210" cy="3481602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067003" y="1792778"/>
              <a:ext cx="4455486" cy="2896826"/>
            </a:xfrm>
            <a:prstGeom prst="rect">
              <a:avLst/>
            </a:prstGeom>
          </p:spPr>
        </p:pic>
        <p:grpSp>
          <p:nvGrpSpPr>
            <p:cNvPr id="8" name="Group 7"/>
            <p:cNvGrpSpPr/>
            <p:nvPr/>
          </p:nvGrpSpPr>
          <p:grpSpPr>
            <a:xfrm>
              <a:off x="324279" y="1208002"/>
              <a:ext cx="5001080" cy="3387032"/>
              <a:chOff x="324279" y="1208002"/>
              <a:chExt cx="5001080" cy="3387032"/>
            </a:xfrm>
          </p:grpSpPr>
          <p:pic>
            <p:nvPicPr>
              <p:cNvPr id="3" name="Picture 2"/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324279" y="1606870"/>
                <a:ext cx="3943459" cy="2988164"/>
              </a:xfrm>
              <a:prstGeom prst="rect">
                <a:avLst/>
              </a:prstGeom>
            </p:spPr>
          </p:pic>
          <p:sp>
            <p:nvSpPr>
              <p:cNvPr id="6" name="TextBox 5"/>
              <p:cNvSpPr txBox="1"/>
              <p:nvPr/>
            </p:nvSpPr>
            <p:spPr>
              <a:xfrm>
                <a:off x="824209" y="1208002"/>
                <a:ext cx="479618" cy="58477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3200" b="1" dirty="0" smtClean="0">
                    <a:latin typeface="Arial"/>
                    <a:cs typeface="Arial"/>
                  </a:rPr>
                  <a:t>A</a:t>
                </a:r>
                <a:endParaRPr lang="en-US" sz="3200" b="1" dirty="0">
                  <a:latin typeface="Arial"/>
                  <a:cs typeface="Arial"/>
                </a:endParaRPr>
              </a:p>
            </p:txBody>
          </p:sp>
          <p:sp>
            <p:nvSpPr>
              <p:cNvPr id="7" name="TextBox 6"/>
              <p:cNvSpPr txBox="1"/>
              <p:nvPr/>
            </p:nvSpPr>
            <p:spPr>
              <a:xfrm>
                <a:off x="4844338" y="1208002"/>
                <a:ext cx="481021" cy="58477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3200" b="1" dirty="0">
                    <a:latin typeface="Arial"/>
                    <a:cs typeface="Arial"/>
                  </a:rPr>
                  <a:t>B</a:t>
                </a:r>
                <a:endParaRPr lang="en-US" sz="3200" b="1" dirty="0">
                  <a:latin typeface="Arial"/>
                  <a:cs typeface="Arial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34737044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Figure S2.eps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98963" y="0"/>
            <a:ext cx="5483924" cy="685800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71248" y="99882"/>
            <a:ext cx="24277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upplementary Fig </a:t>
            </a:r>
            <a:r>
              <a:rPr lang="en-US" dirty="0" smtClean="0"/>
              <a:t>3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1968375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Figure S4.eps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9629" y="976754"/>
            <a:ext cx="7677838" cy="4900084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71249" y="99882"/>
            <a:ext cx="35714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upplementary Fig </a:t>
            </a:r>
            <a:r>
              <a:rPr lang="en-US" dirty="0" smtClean="0"/>
              <a:t>4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2771388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Figure S4.eps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47104" y="866030"/>
            <a:ext cx="7493000" cy="520700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71249" y="99882"/>
            <a:ext cx="35714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upplementary Fig </a:t>
            </a:r>
            <a:r>
              <a:rPr lang="en-US" dirty="0" smtClean="0"/>
              <a:t>5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393483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Figure S5.eps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106" y="1107819"/>
            <a:ext cx="8778431" cy="453935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71249" y="99882"/>
            <a:ext cx="35714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upplementary Fig </a:t>
            </a:r>
            <a:r>
              <a:rPr lang="en-US" dirty="0" smtClean="0"/>
              <a:t>6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1551249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069</TotalTime>
  <Words>21</Words>
  <Application>Microsoft Macintosh PowerPoint</Application>
  <PresentationFormat>On-screen Show (4:3)</PresentationFormat>
  <Paragraphs>9</Paragraphs>
  <Slides>6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7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Institute of Cellular Medicin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mes Macfarlane</dc:creator>
  <cp:lastModifiedBy>James Macfarlane</cp:lastModifiedBy>
  <cp:revision>42</cp:revision>
  <dcterms:created xsi:type="dcterms:W3CDTF">2016-11-05T15:57:19Z</dcterms:created>
  <dcterms:modified xsi:type="dcterms:W3CDTF">2020-08-27T19:59:08Z</dcterms:modified>
</cp:coreProperties>
</file>